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A6191806-6DAC-4DE2-9774-5894D038C20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8DC3790-E83E-4918-9412-EDED5EDA8B9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CB33B7F-6F36-4053-906B-8109EAD318F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E779C9F-9E13-4485-92FD-4F6CD2F94E1F}"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4DB3FFF-809D-45CE-A569-5C7A5BB09A4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9A7EF46-7DB1-4482-A99A-C21F4ECBD4D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006D4E4-981D-47BE-BBE7-5D8F68A9CE2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27CBA93-AB96-455B-A80A-6A6D8C6B57A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167EBC4-AD97-4A2B-9363-87562E402CA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4684137-0ED5-4072-8FF9-439DFA653A9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24B29DD-802E-4570-86EF-9EEED540B08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176A0F1-7F7B-46D1-9A15-2E9A55E1634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A7C0376-EB24-4C4D-9D63-2217E73FF084}"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3" descr=""/>
          <p:cNvPicPr/>
          <p:nvPr/>
        </p:nvPicPr>
        <p:blipFill>
          <a:blip r:embed="rId1"/>
          <a:srcRect l="0" t="0" r="11990" b="0"/>
          <a:stretch/>
        </p:blipFill>
        <p:spPr>
          <a:xfrm>
            <a:off x="179280" y="1125360"/>
            <a:ext cx="3961080" cy="3225960"/>
          </a:xfrm>
          <a:prstGeom prst="rect">
            <a:avLst/>
          </a:prstGeom>
          <a:ln w="0">
            <a:noFill/>
          </a:ln>
        </p:spPr>
      </p:pic>
      <p:pic>
        <p:nvPicPr>
          <p:cNvPr id="42" name="Picture 4" descr=""/>
          <p:cNvPicPr/>
          <p:nvPr/>
        </p:nvPicPr>
        <p:blipFill>
          <a:blip r:embed="rId2"/>
          <a:srcRect l="0" t="0" r="12378" b="0"/>
          <a:stretch/>
        </p:blipFill>
        <p:spPr>
          <a:xfrm>
            <a:off x="4427640" y="1125360"/>
            <a:ext cx="3744720" cy="3213360"/>
          </a:xfrm>
          <a:prstGeom prst="rect">
            <a:avLst/>
          </a:prstGeom>
          <a:ln w="0">
            <a:noFill/>
          </a:ln>
        </p:spPr>
      </p:pic>
      <p:sp>
        <p:nvSpPr>
          <p:cNvPr id="43" name="TekstSylinder 4"/>
          <p:cNvSpPr/>
          <p:nvPr/>
        </p:nvSpPr>
        <p:spPr>
          <a:xfrm>
            <a:off x="250920" y="4724280"/>
            <a:ext cx="8281800" cy="1006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Figure S1: </a:t>
            </a:r>
            <a:r>
              <a:rPr b="0" lang="en-GB" sz="1200" spc="-1" strike="noStrike">
                <a:solidFill>
                  <a:srgbClr val="000000"/>
                </a:solidFill>
                <a:latin typeface="Arial"/>
              </a:rPr>
              <a:t>Control of viability of the cells before and after incubation for one (A) or two (B) hours with trypsin or trypsin beads or without any enzyme. Colony forming units were determined by plating appropriate dilutions of the cell suspensions on MRS plates. Note that the various treatments were done with different cell cultures and that this explains why the numbers of cells vary between the different treatments.</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11-17T10:34:26Z</dcterms:created>
  <dc:creator>geirma</dc:creator>
  <dc:description/>
  <dc:language>en-US</dc:language>
  <cp:lastModifiedBy>geirma</cp:lastModifiedBy>
  <dcterms:modified xsi:type="dcterms:W3CDTF">2010-11-29T18:38:36Z</dcterms:modified>
  <cp:revision>3</cp:revision>
  <dc:subject/>
  <dc:title>Lysbilde 1</dc:title>
</cp:coreProperties>
</file>